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1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8854F1-94C0-4014-A8EC-E4E10ED118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122F495-E039-46AC-B04D-C68CB5FA1F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64C202-426A-4A51-9CCB-E7163274A0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C18F83-EA8B-45B2-8C6D-F73EEFFBE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84DB54-65C4-4590-9DFE-C85E66004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3043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A0F817-122B-4EE3-86D7-40770EEAA4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2884DB1-372E-4CD6-8A94-C01A13C103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A3DFA8-C54B-4C9C-AF33-3E8BB1F21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62F0F2-25BE-49E1-BDE3-863383EDE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ACE27BC-E68E-40B8-BEFD-23AFF1B85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CFFE2A4-C044-4656-BD18-9FC7F38178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6783F0-7FDD-41D7-929F-24FE99FDFF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1BD181-2999-4844-A42B-EE5AE684A8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ED3D102-FD1F-43EB-BDCE-4EC23D8D1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D78DA6-6DD2-40E4-9463-9582B9EC8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2266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DDE2B6-447A-4626-A495-75EE7C289B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EE29A3D-7E9B-40EA-B9A1-879E13F883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75005E-E969-4076-95E2-7E7E54C22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7C39AF-C8B5-4C92-A824-251790938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9C52E7-9BC9-460A-A329-8854D8F78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7560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FE40EA-9D76-4482-9D9B-1607C10FD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794377A-BE91-407A-AB00-843D889FB9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6BAFDB-8F8A-48A1-B48C-0835FCC42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D53D0B-874F-4359-BDDD-8FCD2B589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A93046-4E2A-4229-B7A1-EB31D368A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204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59C28E-23BD-44B1-AF89-2AD2CFB066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D595C8C-E4BF-4ECC-88FB-03A480D044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62257EF-C13C-4FA0-8C33-9B7B16D511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B49A323-C099-471B-8CC5-5DE9D070FE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95A868E-AB2C-4168-93FB-C635E13C1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1C355ED-C909-43A5-B3F8-BEF930664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6841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1EB7EB-E7FA-498C-863C-17307D719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8F99066-6287-45C2-9B10-94B74163D4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E878FE3-02B8-4967-A7F5-6FF9954552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F6E4325-00EB-4D07-9007-976582F93F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3CF74E8-1D9A-45DD-9EBD-C4B6310F5C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441ABDB-1614-448E-903B-DFE03C344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E9F68FA-8FB1-4354-9EBA-63695CABF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AE735E3-B2DD-484A-860D-9A48CBB80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9987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8CFFB2-3814-420B-BB1E-19ECE9FF03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9E8F3DC-A6FF-42F7-B5AA-630716B9C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F4068FB-0C47-4BEC-B538-B606B6904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083FB3E-2E62-417F-AAE7-533861C73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3083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7E327CD-7417-4BEA-9BD8-30A2F87E3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4D25389-91A4-4F55-847D-FFA620258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AAEBEC9-2BFA-45B2-9115-82F530973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3621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68A193-318A-4798-9E2B-9C3F54F6D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0029EAE-9D6A-4F20-8312-38478BF620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48A01DC-5994-4126-87D7-451AF1784B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0B6E19F-A96A-4649-AD53-7B0C9A000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5FEBB9A-3F2C-4ECE-BF19-8BF10C1B14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1424A4E-3B5D-43AB-8E7A-AFF91DB82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8244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E2C3F6-EB94-415D-BF48-8D88A71B7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F898191-507B-4557-AAFD-D00466737B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698DE2E-91A1-4031-A42F-53B3715D54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89D6CF6-FEF4-47CF-828D-869B4DE28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39CFE3F-604B-464E-A053-1CCE7A8AF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318279D-9D7C-46D9-AB01-39CD1C076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4667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6728D96-3553-4486-BBBA-8A1C3DAD56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56140C2-8834-475A-B313-A31A3EAB8F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9E42B5-388F-4DFB-8249-3237E58076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8CD1A-0FE8-4BFE-BAA1-A6CA3F015D72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1463852-2532-46B1-8E03-92C77A1A49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0F3DE9D-0338-4A8C-AC40-A77F9F9086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13F758-F6BB-4655-A19C-202EFF2D05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3317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1C0CAB37-0FB1-48E3-B520-2379690056A6}"/>
              </a:ext>
            </a:extLst>
          </p:cNvPr>
          <p:cNvGrpSpPr/>
          <p:nvPr/>
        </p:nvGrpSpPr>
        <p:grpSpPr>
          <a:xfrm>
            <a:off x="101262" y="1004187"/>
            <a:ext cx="5629575" cy="3859577"/>
            <a:chOff x="101262" y="1004187"/>
            <a:chExt cx="5629575" cy="3859577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2DB7A3BB-9B82-4914-92AE-DFB0DCEB91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89" r="122"/>
            <a:stretch/>
          </p:blipFill>
          <p:spPr>
            <a:xfrm>
              <a:off x="175799" y="1435395"/>
              <a:ext cx="5555038" cy="3428369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04CDF2F1-048B-45BD-BC8A-6CA1AD248A28}"/>
                </a:ext>
              </a:extLst>
            </p:cNvPr>
            <p:cNvSpPr txBox="1"/>
            <p:nvPr/>
          </p:nvSpPr>
          <p:spPr>
            <a:xfrm>
              <a:off x="101262" y="1004187"/>
              <a:ext cx="13019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400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Plasma_</a:t>
              </a:r>
              <a:r>
                <a:rPr lang="en-US" altLang="zh-CN" sz="1200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pos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F91EB080-526D-4B8C-BDBF-9A8B99FF6BCC}"/>
              </a:ext>
            </a:extLst>
          </p:cNvPr>
          <p:cNvGrpSpPr/>
          <p:nvPr/>
        </p:nvGrpSpPr>
        <p:grpSpPr>
          <a:xfrm>
            <a:off x="5803892" y="1007732"/>
            <a:ext cx="5881973" cy="3881642"/>
            <a:chOff x="5803892" y="1007732"/>
            <a:chExt cx="5881973" cy="3881642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C5BD1877-87DF-4EA2-8E38-9D13AE4E1CB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117663" y="1462174"/>
              <a:ext cx="5568202" cy="3427200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D06FF864-45C4-44CD-AA34-55AD95ECA888}"/>
                </a:ext>
              </a:extLst>
            </p:cNvPr>
            <p:cNvSpPr txBox="1"/>
            <p:nvPr/>
          </p:nvSpPr>
          <p:spPr>
            <a:xfrm>
              <a:off x="5803892" y="1007732"/>
              <a:ext cx="13019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Plasma_neg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9" name="文本框 8">
            <a:extLst>
              <a:ext uri="{FF2B5EF4-FFF2-40B4-BE49-F238E27FC236}">
                <a16:creationId xmlns:a16="http://schemas.microsoft.com/office/drawing/2014/main" id="{D92CDE39-5FA4-44AB-B7BA-21024EC37D58}"/>
              </a:ext>
            </a:extLst>
          </p:cNvPr>
          <p:cNvSpPr txBox="1"/>
          <p:nvPr/>
        </p:nvSpPr>
        <p:spPr>
          <a:xfrm>
            <a:off x="0" y="5369442"/>
            <a:ext cx="11738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A. Total Ion Chromatograms (TIC) of QC samples (pooled lipid extracts of plasma) in positive and negative modes. 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A09D998-C2D4-475B-8491-CF61969716DF}"/>
              </a:ext>
            </a:extLst>
          </p:cNvPr>
          <p:cNvSpPr txBox="1"/>
          <p:nvPr/>
        </p:nvSpPr>
        <p:spPr>
          <a:xfrm>
            <a:off x="154425" y="167009"/>
            <a:ext cx="8718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5587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948C614-9A0A-427C-9060-295CCD20DA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20" r="122"/>
          <a:stretch/>
        </p:blipFill>
        <p:spPr>
          <a:xfrm>
            <a:off x="260858" y="1629314"/>
            <a:ext cx="5566414" cy="34272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BAF99A7-FFF5-4560-837B-AFAF505742A2}"/>
              </a:ext>
            </a:extLst>
          </p:cNvPr>
          <p:cNvSpPr txBox="1"/>
          <p:nvPr/>
        </p:nvSpPr>
        <p:spPr>
          <a:xfrm>
            <a:off x="154425" y="167009"/>
            <a:ext cx="8718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0A7CA4E-5326-4D39-800C-0077C5ED4DE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79" r="122"/>
          <a:stretch/>
        </p:blipFill>
        <p:spPr>
          <a:xfrm>
            <a:off x="6183190" y="1618681"/>
            <a:ext cx="5552600" cy="34272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383E6449-C000-4CBF-8895-21D5FA13CA8A}"/>
              </a:ext>
            </a:extLst>
          </p:cNvPr>
          <p:cNvSpPr txBox="1"/>
          <p:nvPr/>
        </p:nvSpPr>
        <p:spPr>
          <a:xfrm>
            <a:off x="101262" y="1004187"/>
            <a:ext cx="13019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V_pos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3AA3F05-3FE9-4A9C-BBE1-E6ED5DC8A249}"/>
              </a:ext>
            </a:extLst>
          </p:cNvPr>
          <p:cNvSpPr txBox="1"/>
          <p:nvPr/>
        </p:nvSpPr>
        <p:spPr>
          <a:xfrm>
            <a:off x="5803892" y="1007732"/>
            <a:ext cx="13019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V</a:t>
            </a:r>
            <a:r>
              <a:rPr kumimoji="0" lang="en-US" altLang="zh-CN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_neg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D536A02-284C-406D-8A59-E3B9C19EDBAE}"/>
              </a:ext>
            </a:extLst>
          </p:cNvPr>
          <p:cNvSpPr txBox="1"/>
          <p:nvPr/>
        </p:nvSpPr>
        <p:spPr>
          <a:xfrm>
            <a:off x="0" y="5369442"/>
            <a:ext cx="117383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B. Total Ion Chromatograms (TIC) of QC samples (pooled lipid extracts of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vesicle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positive and negative modes. 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66755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A141739-C9F8-4F18-AC06-F590CEE0A97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20" r="122"/>
          <a:stretch/>
        </p:blipFill>
        <p:spPr>
          <a:xfrm>
            <a:off x="239589" y="1565519"/>
            <a:ext cx="5566414" cy="34272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C9F6D5DB-2D2D-4F00-ACF1-68E12293304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20" r="122"/>
          <a:stretch/>
        </p:blipFill>
        <p:spPr>
          <a:xfrm>
            <a:off x="6119393" y="1550318"/>
            <a:ext cx="5566414" cy="34272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D43F8D6A-1138-47EF-91F8-B8AA42F632CF}"/>
              </a:ext>
            </a:extLst>
          </p:cNvPr>
          <p:cNvSpPr txBox="1"/>
          <p:nvPr/>
        </p:nvSpPr>
        <p:spPr>
          <a:xfrm>
            <a:off x="101262" y="1004187"/>
            <a:ext cx="13019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o_pos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5F2A40D-68B2-4687-8D04-6D72B98840A6}"/>
              </a:ext>
            </a:extLst>
          </p:cNvPr>
          <p:cNvSpPr txBox="1"/>
          <p:nvPr/>
        </p:nvSpPr>
        <p:spPr>
          <a:xfrm>
            <a:off x="5803892" y="1007732"/>
            <a:ext cx="13019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o_neg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FEBECF2-8BDA-40B2-8DCC-0D66BCEC1F76}"/>
              </a:ext>
            </a:extLst>
          </p:cNvPr>
          <p:cNvSpPr txBox="1"/>
          <p:nvPr/>
        </p:nvSpPr>
        <p:spPr>
          <a:xfrm>
            <a:off x="154425" y="167009"/>
            <a:ext cx="8718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9321081-4DEE-4DD3-AA2B-2F6210A34B33}"/>
              </a:ext>
            </a:extLst>
          </p:cNvPr>
          <p:cNvSpPr txBox="1"/>
          <p:nvPr/>
        </p:nvSpPr>
        <p:spPr>
          <a:xfrm>
            <a:off x="0" y="5369442"/>
            <a:ext cx="117383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C. Total Ion Chromatograms (TIC) of QC samples (pooled lipid extracts of exosomes) in positive and negative modes. 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590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102</Words>
  <Application>Microsoft Office PowerPoint</Application>
  <PresentationFormat>宽屏</PresentationFormat>
  <Paragraphs>1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倩倩(Qianqian Zhao)</dc:creator>
  <cp:lastModifiedBy>赵倩倩(Qianqian Zhao)</cp:lastModifiedBy>
  <cp:revision>9</cp:revision>
  <dcterms:created xsi:type="dcterms:W3CDTF">2019-10-28T10:06:49Z</dcterms:created>
  <dcterms:modified xsi:type="dcterms:W3CDTF">2020-05-18T07:15:50Z</dcterms:modified>
</cp:coreProperties>
</file>